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ell%20viability%20and%20storage%20cabonhydrates%20in%20tor1%20rimyakmck%20mutan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ell%20viability%20and%20storage%20cabonhydrates%20in%20tor1%20rimyakmck%20mutant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ell%20viability%20and%20storage%20cabonhydrates%20in%20tor1%20rimyakmck%20mutant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ell%20viability%20and%20storage%20cabonhydrates%20in%20tor1%20rimyakmck%20mutant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hronological%20life%20span%20and%20storage%20carbohydrates\Cell%20viability%20and%20storage%20cabonhydrates%20in%20tor1%20rimyakmck%20muta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0.12406737446107563"/>
          <c:y val="5.1400554097404488E-2"/>
          <c:w val="0.86790443987294386"/>
          <c:h val="0.8326195683872849"/>
        </c:manualLayout>
      </c:layout>
      <c:lineChart>
        <c:grouping val="standard"/>
        <c:ser>
          <c:idx val="0"/>
          <c:order val="0"/>
          <c:tx>
            <c:v>WT H2O</c:v>
          </c:tx>
          <c:errBars>
            <c:errDir val="y"/>
            <c:errBarType val="both"/>
            <c:errValType val="cust"/>
            <c:plus>
              <c:numRef>
                <c:f>'WT and tor1'!$C$3:$I$3</c:f>
                <c:numCache>
                  <c:formatCode>General</c:formatCode>
                  <c:ptCount val="7"/>
                  <c:pt idx="0">
                    <c:v>4.4448384330232704</c:v>
                  </c:pt>
                  <c:pt idx="1">
                    <c:v>2.7392890246157724</c:v>
                  </c:pt>
                  <c:pt idx="2">
                    <c:v>6.4352816085497118</c:v>
                  </c:pt>
                  <c:pt idx="3">
                    <c:v>6.3685160740830034</c:v>
                  </c:pt>
                  <c:pt idx="4">
                    <c:v>1.715952092703374</c:v>
                  </c:pt>
                  <c:pt idx="5">
                    <c:v>11.030593409130848</c:v>
                  </c:pt>
                  <c:pt idx="6">
                    <c:v>2.1573586571142584</c:v>
                  </c:pt>
                </c:numCache>
              </c:numRef>
            </c:plus>
            <c:minus>
              <c:numRef>
                <c:f>'WT and tor1'!$C$4:$I$4</c:f>
                <c:numCache>
                  <c:formatCode>General</c:formatCode>
                  <c:ptCount val="7"/>
                  <c:pt idx="0">
                    <c:v>4.4448384330232704</c:v>
                  </c:pt>
                  <c:pt idx="1">
                    <c:v>2.7392890246157724</c:v>
                  </c:pt>
                  <c:pt idx="2">
                    <c:v>6.4352816085497118</c:v>
                  </c:pt>
                  <c:pt idx="3">
                    <c:v>6.3685160740830034</c:v>
                  </c:pt>
                  <c:pt idx="4">
                    <c:v>1.715952092703374</c:v>
                  </c:pt>
                  <c:pt idx="5">
                    <c:v>11.030593409130848</c:v>
                  </c:pt>
                  <c:pt idx="6">
                    <c:v>2.1573586571142584</c:v>
                  </c:pt>
                </c:numCache>
              </c:numRef>
            </c:minus>
          </c:errBars>
          <c:cat>
            <c:numRef>
              <c:f>'WT and tor1'!$C$12:$I$12</c:f>
              <c:numCache>
                <c:formatCode>General</c:formatCode>
                <c:ptCount val="7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</c:numCache>
            </c:numRef>
          </c:cat>
          <c:val>
            <c:numRef>
              <c:f>'WT and tor1'!$C$2:$I$2</c:f>
              <c:numCache>
                <c:formatCode>General</c:formatCode>
                <c:ptCount val="7"/>
                <c:pt idx="0">
                  <c:v>100</c:v>
                </c:pt>
                <c:pt idx="1">
                  <c:v>79.893238434163678</c:v>
                </c:pt>
                <c:pt idx="2">
                  <c:v>73.843416370106752</c:v>
                </c:pt>
                <c:pt idx="3">
                  <c:v>72.7758007117435</c:v>
                </c:pt>
                <c:pt idx="4">
                  <c:v>76.690391459074718</c:v>
                </c:pt>
                <c:pt idx="5">
                  <c:v>77.40213523131672</c:v>
                </c:pt>
                <c:pt idx="6">
                  <c:v>64.94661921708186</c:v>
                </c:pt>
              </c:numCache>
            </c:numRef>
          </c:val>
        </c:ser>
        <c:ser>
          <c:idx val="1"/>
          <c:order val="1"/>
          <c:tx>
            <c:v>tor1∆ H2O</c:v>
          </c:tx>
          <c:errBars>
            <c:errDir val="y"/>
            <c:errBarType val="both"/>
            <c:errValType val="cust"/>
            <c:plus>
              <c:numRef>
                <c:f>'WT and tor1'!$C$6:$I$6</c:f>
                <c:numCache>
                  <c:formatCode>General</c:formatCode>
                  <c:ptCount val="7"/>
                  <c:pt idx="0">
                    <c:v>11.728395061728298</c:v>
                  </c:pt>
                  <c:pt idx="1">
                    <c:v>2.8511124404425972</c:v>
                  </c:pt>
                  <c:pt idx="2">
                    <c:v>1.8858336193233878</c:v>
                  </c:pt>
                  <c:pt idx="3">
                    <c:v>3.6169538747418777</c:v>
                  </c:pt>
                  <c:pt idx="4">
                    <c:v>8.5607588735450246</c:v>
                  </c:pt>
                  <c:pt idx="5">
                    <c:v>4.0163006781777266</c:v>
                  </c:pt>
                  <c:pt idx="6">
                    <c:v>3.7037037037037202</c:v>
                  </c:pt>
                </c:numCache>
              </c:numRef>
            </c:plus>
            <c:minus>
              <c:numRef>
                <c:f>'WT and tor1'!$C$7:$I$7</c:f>
                <c:numCache>
                  <c:formatCode>General</c:formatCode>
                  <c:ptCount val="7"/>
                  <c:pt idx="0">
                    <c:v>11.728395061728298</c:v>
                  </c:pt>
                  <c:pt idx="1">
                    <c:v>2.8511124404425972</c:v>
                  </c:pt>
                  <c:pt idx="2">
                    <c:v>1.8858336193233878</c:v>
                  </c:pt>
                  <c:pt idx="3">
                    <c:v>3.6169538747418777</c:v>
                  </c:pt>
                  <c:pt idx="4">
                    <c:v>8.5607588735450246</c:v>
                  </c:pt>
                  <c:pt idx="5">
                    <c:v>4.0163006781777266</c:v>
                  </c:pt>
                  <c:pt idx="6">
                    <c:v>3.7037037037037202</c:v>
                  </c:pt>
                </c:numCache>
              </c:numRef>
            </c:minus>
          </c:errBars>
          <c:cat>
            <c:numRef>
              <c:f>'WT and tor1'!$C$12:$I$12</c:f>
              <c:numCache>
                <c:formatCode>General</c:formatCode>
                <c:ptCount val="7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</c:numCache>
            </c:numRef>
          </c:cat>
          <c:val>
            <c:numRef>
              <c:f>'WT and tor1'!$C$5:$I$5</c:f>
              <c:numCache>
                <c:formatCode>General</c:formatCode>
                <c:ptCount val="7"/>
                <c:pt idx="0">
                  <c:v>100</c:v>
                </c:pt>
                <c:pt idx="1">
                  <c:v>96.502057613168688</c:v>
                </c:pt>
                <c:pt idx="2">
                  <c:v>86.831275720164612</c:v>
                </c:pt>
                <c:pt idx="3">
                  <c:v>87.242798353909023</c:v>
                </c:pt>
                <c:pt idx="4">
                  <c:v>84.156378600822606</c:v>
                </c:pt>
                <c:pt idx="5">
                  <c:v>84.77366255144031</c:v>
                </c:pt>
                <c:pt idx="6">
                  <c:v>45.061728395061763</c:v>
                </c:pt>
              </c:numCache>
            </c:numRef>
          </c:val>
        </c:ser>
        <c:marker val="1"/>
        <c:axId val="76779520"/>
        <c:axId val="76781056"/>
      </c:lineChart>
      <c:catAx>
        <c:axId val="76779520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76781056"/>
        <c:crosses val="autoZero"/>
        <c:auto val="1"/>
        <c:lblAlgn val="ctr"/>
        <c:lblOffset val="100"/>
      </c:catAx>
      <c:valAx>
        <c:axId val="76781056"/>
        <c:scaling>
          <c:orientation val="minMax"/>
          <c:max val="120"/>
          <c:min val="0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76779520"/>
        <c:crosses val="autoZero"/>
        <c:crossBetween val="between"/>
        <c:majorUnit val="30"/>
      </c:valAx>
    </c:plotArea>
    <c:legend>
      <c:legendPos val="r"/>
      <c:layout>
        <c:manualLayout>
          <c:xMode val="edge"/>
          <c:yMode val="edge"/>
          <c:x val="0.22045093280233818"/>
          <c:y val="0.47270453718634031"/>
          <c:w val="0.55827023493116146"/>
          <c:h val="0.16743438320210088"/>
        </c:manualLayout>
      </c:layout>
      <c:txPr>
        <a:bodyPr/>
        <a:lstStyle/>
        <a:p>
          <a:pPr>
            <a:defRPr i="1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0.12295963004624422"/>
          <c:y val="5.1400554097404488E-2"/>
          <c:w val="0.86801243594550681"/>
          <c:h val="0.8326195683872849"/>
        </c:manualLayout>
      </c:layout>
      <c:lineChart>
        <c:grouping val="standard"/>
        <c:ser>
          <c:idx val="0"/>
          <c:order val="0"/>
          <c:tx>
            <c:v>WT YPD</c:v>
          </c:tx>
          <c:errBars>
            <c:errDir val="y"/>
            <c:errBarType val="both"/>
            <c:errValType val="cust"/>
            <c:plus>
              <c:numRef>
                <c:f>'WT and tor1'!$C$14:$I$14</c:f>
                <c:numCache>
                  <c:formatCode>General</c:formatCode>
                  <c:ptCount val="7"/>
                  <c:pt idx="0">
                    <c:v>4.4448384330232704</c:v>
                  </c:pt>
                  <c:pt idx="1">
                    <c:v>6.7592241684066092</c:v>
                  </c:pt>
                  <c:pt idx="2">
                    <c:v>7.9952462415163303</c:v>
                  </c:pt>
                  <c:pt idx="3">
                    <c:v>5.4525101231476771</c:v>
                  </c:pt>
                  <c:pt idx="4">
                    <c:v>6.6743769870145613</c:v>
                  </c:pt>
                  <c:pt idx="5">
                    <c:v>7.2080530606865052</c:v>
                  </c:pt>
                  <c:pt idx="6">
                    <c:v>1.8491645632407905</c:v>
                  </c:pt>
                </c:numCache>
              </c:numRef>
            </c:plus>
            <c:minus>
              <c:numRef>
                <c:f>'WT and tor1'!$C$15:$I$15</c:f>
                <c:numCache>
                  <c:formatCode>General</c:formatCode>
                  <c:ptCount val="7"/>
                  <c:pt idx="0">
                    <c:v>4.4448384330232704</c:v>
                  </c:pt>
                  <c:pt idx="1">
                    <c:v>6.7592241684066092</c:v>
                  </c:pt>
                  <c:pt idx="2">
                    <c:v>7.9952462415163303</c:v>
                  </c:pt>
                  <c:pt idx="3">
                    <c:v>5.4525101231476771</c:v>
                  </c:pt>
                  <c:pt idx="4">
                    <c:v>6.6743769870145613</c:v>
                  </c:pt>
                  <c:pt idx="5">
                    <c:v>7.2080530606865052</c:v>
                  </c:pt>
                  <c:pt idx="6">
                    <c:v>1.8491645632407905</c:v>
                  </c:pt>
                </c:numCache>
              </c:numRef>
            </c:minus>
          </c:errBars>
          <c:cat>
            <c:numRef>
              <c:f>'WT and tor1'!$C$12:$I$12</c:f>
              <c:numCache>
                <c:formatCode>General</c:formatCode>
                <c:ptCount val="7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</c:numCache>
            </c:numRef>
          </c:cat>
          <c:val>
            <c:numRef>
              <c:f>'WT and tor1'!$C$13:$I$13</c:f>
              <c:numCache>
                <c:formatCode>General</c:formatCode>
                <c:ptCount val="7"/>
                <c:pt idx="0">
                  <c:v>100</c:v>
                </c:pt>
                <c:pt idx="1">
                  <c:v>99.466192170818502</c:v>
                </c:pt>
                <c:pt idx="2">
                  <c:v>76.156583629893234</c:v>
                </c:pt>
                <c:pt idx="3">
                  <c:v>79.715302491103202</c:v>
                </c:pt>
                <c:pt idx="4">
                  <c:v>75.088967971530252</c:v>
                </c:pt>
                <c:pt idx="5">
                  <c:v>55.338078291814938</c:v>
                </c:pt>
                <c:pt idx="6">
                  <c:v>22.41992882562279</c:v>
                </c:pt>
              </c:numCache>
            </c:numRef>
          </c:val>
        </c:ser>
        <c:ser>
          <c:idx val="1"/>
          <c:order val="1"/>
          <c:tx>
            <c:v>tor1∆ YPD</c:v>
          </c:tx>
          <c:errBars>
            <c:errDir val="y"/>
            <c:errBarType val="both"/>
            <c:errValType val="cust"/>
            <c:plus>
              <c:numRef>
                <c:f>'WT and tor1'!$C$20:$I$20</c:f>
                <c:numCache>
                  <c:formatCode>General</c:formatCode>
                  <c:ptCount val="7"/>
                  <c:pt idx="0">
                    <c:v>0.78603356688779658</c:v>
                  </c:pt>
                  <c:pt idx="1">
                    <c:v>1.8553437095012044</c:v>
                  </c:pt>
                  <c:pt idx="2">
                    <c:v>3.3480654023917467</c:v>
                  </c:pt>
                  <c:pt idx="3">
                    <c:v>0.59418552575260963</c:v>
                  </c:pt>
                  <c:pt idx="4">
                    <c:v>5.2812364728439034</c:v>
                  </c:pt>
                  <c:pt idx="5">
                    <c:v>4.9624274927919014</c:v>
                  </c:pt>
                  <c:pt idx="6">
                    <c:v>2.8340843296499187</c:v>
                  </c:pt>
                </c:numCache>
              </c:numRef>
            </c:plus>
            <c:minus>
              <c:numRef>
                <c:f>'WT and tor1'!$C$21:$I$21</c:f>
                <c:numCache>
                  <c:formatCode>General</c:formatCode>
                  <c:ptCount val="7"/>
                  <c:pt idx="0">
                    <c:v>0.78603356688779658</c:v>
                  </c:pt>
                  <c:pt idx="1">
                    <c:v>1.8553437095012044</c:v>
                  </c:pt>
                  <c:pt idx="2">
                    <c:v>3.3480654023917467</c:v>
                  </c:pt>
                  <c:pt idx="3">
                    <c:v>0.59418552575260963</c:v>
                  </c:pt>
                  <c:pt idx="4">
                    <c:v>5.2812364728439034</c:v>
                  </c:pt>
                  <c:pt idx="5">
                    <c:v>4.9624274927919014</c:v>
                  </c:pt>
                  <c:pt idx="6">
                    <c:v>2.8340843296499187</c:v>
                  </c:pt>
                </c:numCache>
              </c:numRef>
            </c:minus>
          </c:errBars>
          <c:cat>
            <c:numRef>
              <c:f>'WT and tor1'!$C$12:$I$12</c:f>
              <c:numCache>
                <c:formatCode>General</c:formatCode>
                <c:ptCount val="7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</c:numCache>
            </c:numRef>
          </c:cat>
          <c:val>
            <c:numRef>
              <c:f>'WT and tor1'!$C$19:$I$19</c:f>
              <c:numCache>
                <c:formatCode>General</c:formatCode>
                <c:ptCount val="7"/>
                <c:pt idx="0">
                  <c:v>100</c:v>
                </c:pt>
                <c:pt idx="1">
                  <c:v>103.9451114922813</c:v>
                </c:pt>
                <c:pt idx="2">
                  <c:v>86.277873070325882</c:v>
                </c:pt>
                <c:pt idx="3">
                  <c:v>84.562607204116631</c:v>
                </c:pt>
                <c:pt idx="4">
                  <c:v>86.106346483704655</c:v>
                </c:pt>
                <c:pt idx="5">
                  <c:v>77.186963979416817</c:v>
                </c:pt>
                <c:pt idx="6">
                  <c:v>66.209262435677815</c:v>
                </c:pt>
              </c:numCache>
            </c:numRef>
          </c:val>
        </c:ser>
        <c:marker val="1"/>
        <c:axId val="77602176"/>
        <c:axId val="77620352"/>
      </c:lineChart>
      <c:catAx>
        <c:axId val="77602176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77620352"/>
        <c:crosses val="autoZero"/>
        <c:auto val="1"/>
        <c:lblAlgn val="ctr"/>
        <c:lblOffset val="100"/>
      </c:catAx>
      <c:valAx>
        <c:axId val="77620352"/>
        <c:scaling>
          <c:orientation val="minMax"/>
          <c:max val="120"/>
          <c:min val="0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77602176"/>
        <c:crosses val="autoZero"/>
        <c:crossBetween val="between"/>
        <c:majorUnit val="30"/>
      </c:valAx>
    </c:plotArea>
    <c:legend>
      <c:legendPos val="r"/>
      <c:layout>
        <c:manualLayout>
          <c:xMode val="edge"/>
          <c:yMode val="edge"/>
          <c:x val="0.25684508186476818"/>
          <c:y val="0.5366531787693205"/>
          <c:w val="0.47880328111691406"/>
          <c:h val="0.16743438320210074"/>
        </c:manualLayout>
      </c:layout>
      <c:txPr>
        <a:bodyPr/>
        <a:lstStyle/>
        <a:p>
          <a:pPr>
            <a:defRPr i="1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8.9585964196017415E-2"/>
          <c:y val="3.9862834241239535E-2"/>
          <c:w val="0.90195193117880956"/>
          <c:h val="0.82686346225755669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GB"/>
                      <a:t>tor1∆</a:t>
                    </a:r>
                  </a:p>
                </c:rich>
              </c:tx>
              <c:showVal val="1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GB"/>
                      <a:t>tor1∆yak1∆</a:t>
                    </a:r>
                  </a:p>
                </c:rich>
              </c:tx>
              <c:showVal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GB"/>
                      <a:t>tor1∆rim15∆</a:t>
                    </a:r>
                  </a:p>
                </c:rich>
              </c:tx>
              <c:showVal val="1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GB"/>
                      <a:t>tor1∆mck1∆</a:t>
                    </a:r>
                  </a:p>
                </c:rich>
              </c:tx>
              <c:showVal val="1"/>
            </c:dLbl>
            <c:dLbl>
              <c:idx val="4"/>
              <c:layout>
                <c:manualLayout>
                  <c:x val="-4.1369919833564792E-2"/>
                  <c:y val="-9.7982889770020523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rim15∆yak1∆</a:t>
                    </a:r>
                  </a:p>
                </c:rich>
              </c:tx>
              <c:showVal val="1"/>
            </c:dLbl>
            <c:dLbl>
              <c:idx val="5"/>
              <c:layout>
                <c:manualLayout>
                  <c:x val="-1.0175151478895507E-2"/>
                  <c:y val="4.5725348559342911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rim15∆mck1∆</a:t>
                    </a:r>
                  </a:p>
                </c:rich>
              </c:tx>
              <c:showVal val="1"/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GB"/>
                      <a:t>tor1∆yak1∆mck1∆</a:t>
                    </a:r>
                  </a:p>
                </c:rich>
              </c:tx>
              <c:showVal val="1"/>
            </c:dLbl>
            <c:dLbl>
              <c:idx val="7"/>
              <c:layout>
                <c:manualLayout>
                  <c:x val="0"/>
                  <c:y val="-2.6128770605338806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rim15∆yak1∆mck1∆</a:t>
                    </a:r>
                  </a:p>
                </c:rich>
              </c:tx>
              <c:showVal val="1"/>
            </c:dLbl>
            <c:delete val="1"/>
          </c:dLbls>
          <c:trendline>
            <c:trendlineType val="linear"/>
            <c:dispRSqr val="1"/>
            <c:trendlineLbl>
              <c:layout>
                <c:manualLayout>
                  <c:x val="-0.52592126515857207"/>
                  <c:y val="-4.0905808445526257E-2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63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K$2:$K$9</c:f>
                <c:numCache>
                  <c:formatCode>General</c:formatCode>
                  <c:ptCount val="8"/>
                  <c:pt idx="0">
                    <c:v>8.5607588735450193</c:v>
                  </c:pt>
                  <c:pt idx="1">
                    <c:v>0.87921360790298597</c:v>
                  </c:pt>
                  <c:pt idx="2">
                    <c:v>2.3199018178457842</c:v>
                  </c:pt>
                  <c:pt idx="3">
                    <c:v>3.1362043951170744</c:v>
                  </c:pt>
                  <c:pt idx="4">
                    <c:v>3.0214116833495823</c:v>
                  </c:pt>
                  <c:pt idx="5">
                    <c:v>2.3304265176546157</c:v>
                  </c:pt>
                  <c:pt idx="6">
                    <c:v>2.3403274280252537</c:v>
                  </c:pt>
                  <c:pt idx="7">
                    <c:v>0.23629615382931476</c:v>
                  </c:pt>
                </c:numCache>
              </c:numRef>
            </c:plus>
            <c:minus>
              <c:numRef>
                <c:f>Sheet1!$K$2:$K$9</c:f>
                <c:numCache>
                  <c:formatCode>General</c:formatCode>
                  <c:ptCount val="8"/>
                  <c:pt idx="0">
                    <c:v>8.5607588735450193</c:v>
                  </c:pt>
                  <c:pt idx="1">
                    <c:v>0.87921360790298597</c:v>
                  </c:pt>
                  <c:pt idx="2">
                    <c:v>2.3199018178457842</c:v>
                  </c:pt>
                  <c:pt idx="3">
                    <c:v>3.1362043951170744</c:v>
                  </c:pt>
                  <c:pt idx="4">
                    <c:v>3.0214116833495823</c:v>
                  </c:pt>
                  <c:pt idx="5">
                    <c:v>2.3304265176546157</c:v>
                  </c:pt>
                  <c:pt idx="6">
                    <c:v>2.3403274280252537</c:v>
                  </c:pt>
                  <c:pt idx="7">
                    <c:v>0.23629615382931476</c:v>
                  </c:pt>
                </c:numCache>
              </c:numRef>
            </c:minus>
          </c:errBars>
          <c:xVal>
            <c:numRef>
              <c:f>Sheet1!$H$2:$H$9</c:f>
              <c:numCache>
                <c:formatCode>General</c:formatCode>
                <c:ptCount val="8"/>
                <c:pt idx="0">
                  <c:v>26.153969398381797</c:v>
                </c:pt>
                <c:pt idx="1">
                  <c:v>16.860265210988224</c:v>
                </c:pt>
                <c:pt idx="2">
                  <c:v>6.2841063318277612</c:v>
                </c:pt>
                <c:pt idx="3">
                  <c:v>9.0924048180133852</c:v>
                </c:pt>
                <c:pt idx="4">
                  <c:v>0.96923350785401796</c:v>
                </c:pt>
                <c:pt idx="5">
                  <c:v>0.54653933476843597</c:v>
                </c:pt>
                <c:pt idx="6">
                  <c:v>8.6362909110012929</c:v>
                </c:pt>
                <c:pt idx="7">
                  <c:v>0.19004222643488355</c:v>
                </c:pt>
              </c:numCache>
            </c:numRef>
          </c:xVal>
          <c:yVal>
            <c:numRef>
              <c:f>Sheet1!$J$2:$J$9</c:f>
              <c:numCache>
                <c:formatCode>General</c:formatCode>
                <c:ptCount val="8"/>
                <c:pt idx="0">
                  <c:v>84.156378600823047</c:v>
                </c:pt>
                <c:pt idx="1">
                  <c:v>75.126903553299499</c:v>
                </c:pt>
                <c:pt idx="2">
                  <c:v>50.416666666666679</c:v>
                </c:pt>
                <c:pt idx="3">
                  <c:v>42.341040462427749</c:v>
                </c:pt>
                <c:pt idx="4">
                  <c:v>42.318435754189949</c:v>
                </c:pt>
                <c:pt idx="5">
                  <c:v>33.060109289617486</c:v>
                </c:pt>
                <c:pt idx="6">
                  <c:v>78.895184135977331</c:v>
                </c:pt>
                <c:pt idx="7">
                  <c:v>0.27285129604365621</c:v>
                </c:pt>
              </c:numCache>
            </c:numRef>
          </c:yVal>
        </c:ser>
        <c:axId val="45422848"/>
        <c:axId val="45603072"/>
      </c:scatterChart>
      <c:valAx>
        <c:axId val="45422848"/>
        <c:scaling>
          <c:orientation val="minMax"/>
        </c:scaling>
        <c:axPos val="b"/>
        <c:numFmt formatCode="General" sourceLinked="1"/>
        <c:tickLblPos val="nextTo"/>
        <c:crossAx val="45603072"/>
        <c:crosses val="autoZero"/>
        <c:crossBetween val="midCat"/>
      </c:valAx>
      <c:valAx>
        <c:axId val="45603072"/>
        <c:scaling>
          <c:orientation val="minMax"/>
          <c:max val="100"/>
          <c:min val="0"/>
        </c:scaling>
        <c:axPos val="l"/>
        <c:majorGridlines/>
        <c:numFmt formatCode="General" sourceLinked="1"/>
        <c:tickLblPos val="nextTo"/>
        <c:crossAx val="45422848"/>
        <c:crosses val="autoZero"/>
        <c:crossBetween val="midCat"/>
        <c:majorUnit val="20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8.8136574568637674E-2"/>
          <c:y val="4.1007108597249153E-2"/>
          <c:w val="0.87432566253322286"/>
          <c:h val="0.79065326606577369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GB"/>
                      <a:t>tor1∆</a:t>
                    </a:r>
                  </a:p>
                </c:rich>
              </c:tx>
              <c:showVal val="1"/>
            </c:dLbl>
            <c:dLbl>
              <c:idx val="1"/>
              <c:layout>
                <c:manualLayout>
                  <c:x val="3.3917171596318358E-3"/>
                  <c:y val="5.3757609267896495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yak1∆</a:t>
                    </a:r>
                  </a:p>
                </c:rich>
              </c:tx>
              <c:showVal val="1"/>
            </c:dLbl>
            <c:dLbl>
              <c:idx val="2"/>
              <c:layout>
                <c:manualLayout>
                  <c:x val="0"/>
                  <c:y val="-1.3439402316974124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rim15∆</a:t>
                    </a:r>
                  </a:p>
                </c:rich>
              </c:tx>
              <c:showVal val="1"/>
            </c:dLbl>
            <c:dLbl>
              <c:idx val="3"/>
              <c:layout>
                <c:manualLayout>
                  <c:x val="-3.3917171596318358E-3"/>
                  <c:y val="3.359850579243525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mck1∆</a:t>
                    </a:r>
                  </a:p>
                </c:rich>
              </c:tx>
              <c:showVal val="1"/>
            </c:dLbl>
            <c:dLbl>
              <c:idx val="4"/>
              <c:layout>
                <c:manualLayout>
                  <c:x val="-0.1576753224000752"/>
                  <c:y val="-0.11357670644694479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rim15∆yak1∆</a:t>
                    </a:r>
                  </a:p>
                </c:rich>
              </c:tx>
              <c:showVal val="1"/>
            </c:dLbl>
            <c:dLbl>
              <c:idx val="5"/>
              <c:layout>
                <c:manualLayout>
                  <c:x val="-3.3917171596318358E-3"/>
                  <c:y val="8.0636413901844742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rim15∆mck1∆</a:t>
                    </a:r>
                  </a:p>
                </c:rich>
              </c:tx>
              <c:showVal val="1"/>
            </c:dLbl>
            <c:dLbl>
              <c:idx val="6"/>
              <c:layout>
                <c:manualLayout>
                  <c:x val="-3.0525454436686458E-2"/>
                  <c:y val="-6.0477310426383574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yak1∆mck1∆</a:t>
                    </a:r>
                  </a:p>
                </c:rich>
              </c:tx>
              <c:showVal val="1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GB"/>
                      <a:t>tor1∆rim15∆yak1∆mck1∆</a:t>
                    </a:r>
                  </a:p>
                </c:rich>
              </c:tx>
              <c:showVal val="1"/>
            </c:dLbl>
            <c:delete val="1"/>
          </c:dLbls>
          <c:trendline>
            <c:trendlineType val="linear"/>
            <c:dispRSqr val="1"/>
            <c:trendlineLbl>
              <c:layout>
                <c:manualLayout>
                  <c:x val="-0.53153175288215837"/>
                  <c:y val="-4.4845711587601381E-2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78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K$2:$K$9</c:f>
                <c:numCache>
                  <c:formatCode>General</c:formatCode>
                  <c:ptCount val="8"/>
                  <c:pt idx="0">
                    <c:v>8.5607588735450193</c:v>
                  </c:pt>
                  <c:pt idx="1">
                    <c:v>0.87921360790298597</c:v>
                  </c:pt>
                  <c:pt idx="2">
                    <c:v>2.3199018178457842</c:v>
                  </c:pt>
                  <c:pt idx="3">
                    <c:v>3.1362043951170744</c:v>
                  </c:pt>
                  <c:pt idx="4">
                    <c:v>3.0214116833495823</c:v>
                  </c:pt>
                  <c:pt idx="5">
                    <c:v>2.3304265176546157</c:v>
                  </c:pt>
                  <c:pt idx="6">
                    <c:v>2.3403274280252537</c:v>
                  </c:pt>
                  <c:pt idx="7">
                    <c:v>0.23629615382931476</c:v>
                  </c:pt>
                </c:numCache>
              </c:numRef>
            </c:plus>
            <c:minus>
              <c:numRef>
                <c:f>Sheet1!$K$2:$K$9</c:f>
                <c:numCache>
                  <c:formatCode>General</c:formatCode>
                  <c:ptCount val="8"/>
                  <c:pt idx="0">
                    <c:v>8.5607588735450193</c:v>
                  </c:pt>
                  <c:pt idx="1">
                    <c:v>0.87921360790298597</c:v>
                  </c:pt>
                  <c:pt idx="2">
                    <c:v>2.3199018178457842</c:v>
                  </c:pt>
                  <c:pt idx="3">
                    <c:v>3.1362043951170744</c:v>
                  </c:pt>
                  <c:pt idx="4">
                    <c:v>3.0214116833495823</c:v>
                  </c:pt>
                  <c:pt idx="5">
                    <c:v>2.3304265176546157</c:v>
                  </c:pt>
                  <c:pt idx="6">
                    <c:v>2.3403274280252537</c:v>
                  </c:pt>
                  <c:pt idx="7">
                    <c:v>0.23629615382931476</c:v>
                  </c:pt>
                </c:numCache>
              </c:numRef>
            </c:minus>
          </c:errBars>
          <c:xVal>
            <c:numRef>
              <c:f>Sheet1!$N$2:$N$9</c:f>
              <c:numCache>
                <c:formatCode>General</c:formatCode>
                <c:ptCount val="8"/>
                <c:pt idx="0">
                  <c:v>39.519723294268431</c:v>
                </c:pt>
                <c:pt idx="1">
                  <c:v>37.439790472365331</c:v>
                </c:pt>
                <c:pt idx="2">
                  <c:v>13.612146338082646</c:v>
                </c:pt>
                <c:pt idx="3">
                  <c:v>13.857794888277057</c:v>
                </c:pt>
                <c:pt idx="4">
                  <c:v>9.4748597753514954</c:v>
                </c:pt>
                <c:pt idx="5">
                  <c:v>3.6873877273121725</c:v>
                </c:pt>
                <c:pt idx="6">
                  <c:v>25.160266074964397</c:v>
                </c:pt>
                <c:pt idx="7">
                  <c:v>4.4541586453634991</c:v>
                </c:pt>
              </c:numCache>
            </c:numRef>
          </c:xVal>
          <c:yVal>
            <c:numRef>
              <c:f>Sheet1!$P$2:$P$9</c:f>
              <c:numCache>
                <c:formatCode>General</c:formatCode>
                <c:ptCount val="8"/>
                <c:pt idx="0">
                  <c:v>84.156378600823047</c:v>
                </c:pt>
                <c:pt idx="1">
                  <c:v>75.126903553299499</c:v>
                </c:pt>
                <c:pt idx="2">
                  <c:v>50.416666666666679</c:v>
                </c:pt>
                <c:pt idx="3">
                  <c:v>42.341040462427749</c:v>
                </c:pt>
                <c:pt idx="4">
                  <c:v>42.318435754189949</c:v>
                </c:pt>
                <c:pt idx="5">
                  <c:v>33.060109289617486</c:v>
                </c:pt>
                <c:pt idx="6">
                  <c:v>78.895184135977331</c:v>
                </c:pt>
                <c:pt idx="7">
                  <c:v>0.27285129604365621</c:v>
                </c:pt>
              </c:numCache>
            </c:numRef>
          </c:yVal>
        </c:ser>
        <c:axId val="73833472"/>
        <c:axId val="73965952"/>
      </c:scatterChart>
      <c:valAx>
        <c:axId val="73833472"/>
        <c:scaling>
          <c:orientation val="minMax"/>
          <c:max val="45"/>
          <c:min val="0"/>
        </c:scaling>
        <c:axPos val="b"/>
        <c:numFmt formatCode="General" sourceLinked="1"/>
        <c:tickLblPos val="nextTo"/>
        <c:crossAx val="73965952"/>
        <c:crosses val="autoZero"/>
        <c:crossBetween val="midCat"/>
      </c:valAx>
      <c:valAx>
        <c:axId val="73965952"/>
        <c:scaling>
          <c:orientation val="minMax"/>
        </c:scaling>
        <c:axPos val="l"/>
        <c:majorGridlines/>
        <c:numFmt formatCode="General" sourceLinked="1"/>
        <c:tickLblPos val="nextTo"/>
        <c:crossAx val="73833472"/>
        <c:crosses val="autoZero"/>
        <c:crossBetween val="midCat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8.8136574568637757E-2"/>
          <c:y val="4.4389612755011812E-2"/>
          <c:w val="0.87432566253322375"/>
          <c:h val="0.80157126206957119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dLbls>
            <c:dLbl>
              <c:idx val="0"/>
              <c:layout>
                <c:manualLayout>
                  <c:x val="0"/>
                  <c:y val="-5.4273787754826899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</a:t>
                    </a:r>
                  </a:p>
                </c:rich>
              </c:tx>
              <c:showVal val="1"/>
            </c:dLbl>
            <c:dLbl>
              <c:idx val="1"/>
              <c:layout>
                <c:manualLayout>
                  <c:x val="-3.2394359810361206E-2"/>
                  <c:y val="5.7205059870124995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yak1∆</a:t>
                    </a:r>
                  </a:p>
                </c:rich>
              </c:tx>
              <c:showVal val="1"/>
            </c:dLbl>
            <c:dLbl>
              <c:idx val="2"/>
              <c:layout>
                <c:manualLayout>
                  <c:x val="-3.391717159631838E-3"/>
                  <c:y val="-7.236505033976906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GB"/>
                      <a:t>tor1∆rim15∆</a:t>
                    </a:r>
                  </a:p>
                </c:rich>
              </c:tx>
              <c:spPr>
                <a:ln w="57150"/>
              </c:spPr>
              <c:showVal val="1"/>
            </c:dLbl>
            <c:dLbl>
              <c:idx val="3"/>
              <c:layout>
                <c:manualLayout>
                  <c:x val="-0.15837242573954369"/>
                  <c:y val="-7.2459742502158309E-2"/>
                </c:manualLayout>
              </c:layout>
              <c:tx>
                <c:rich>
                  <a:bodyPr/>
                  <a:lstStyle/>
                  <a:p>
                    <a:r>
                      <a:rPr lang="en-GB" dirty="0"/>
                      <a:t>tor1∆mck1∆</a:t>
                    </a:r>
                  </a:p>
                </c:rich>
              </c:tx>
              <c:showVal val="1"/>
            </c:dLbl>
            <c:dLbl>
              <c:idx val="4"/>
              <c:layout>
                <c:manualLayout>
                  <c:x val="-3.5993733122623608E-3"/>
                  <c:y val="3.4323035922075001E-2"/>
                </c:manualLayout>
              </c:layout>
              <c:tx>
                <c:rich>
                  <a:bodyPr/>
                  <a:lstStyle/>
                  <a:p>
                    <a:r>
                      <a:rPr lang="en-GB" dirty="0"/>
                      <a:t>tor1∆rim15∆yak1∆</a:t>
                    </a:r>
                  </a:p>
                </c:rich>
              </c:tx>
              <c:showSerName val="1"/>
            </c:dLbl>
            <c:dLbl>
              <c:idx val="5"/>
              <c:layout>
                <c:manualLayout>
                  <c:x val="-6.9691241571449319E-2"/>
                  <c:y val="7.4056892035048727E-2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rim15∆mck1∆</a:t>
                    </a:r>
                  </a:p>
                </c:rich>
              </c:tx>
              <c:showVal val="1"/>
            </c:dLbl>
            <c:dLbl>
              <c:idx val="6"/>
              <c:layout>
                <c:manualLayout>
                  <c:x val="-0.11178832693803252"/>
                  <c:y val="0.1058058707809016"/>
                </c:manualLayout>
              </c:layout>
              <c:tx>
                <c:rich>
                  <a:bodyPr/>
                  <a:lstStyle/>
                  <a:p>
                    <a:r>
                      <a:rPr lang="en-GB"/>
                      <a:t>tor1∆yak1∆mck1∆</a:t>
                    </a:r>
                  </a:p>
                </c:rich>
              </c:tx>
              <c:showVal val="1"/>
            </c:dLbl>
            <c:dLbl>
              <c:idx val="7"/>
              <c:layout>
                <c:manualLayout>
                  <c:x val="-1.3503478649122843E-2"/>
                  <c:y val="-1.251183730908206E-3"/>
                </c:manualLayout>
              </c:layout>
              <c:tx>
                <c:rich>
                  <a:bodyPr/>
                  <a:lstStyle/>
                  <a:p>
                    <a:r>
                      <a:rPr lang="en-GB" dirty="0"/>
                      <a:t>tor1∆rim15∆yak1∆mck1∆</a:t>
                    </a:r>
                  </a:p>
                </c:rich>
              </c:tx>
              <c:showVal val="1"/>
            </c:dLbl>
            <c:delete val="1"/>
          </c:dLbls>
          <c:trendline>
            <c:trendlineType val="linear"/>
            <c:dispRSqr val="1"/>
            <c:trendlineLbl>
              <c:layout>
                <c:manualLayout>
                  <c:x val="-0.48953496781280065"/>
                  <c:y val="-4.285370408578941E-2"/>
                </c:manualLayout>
              </c:layout>
              <c:tx>
                <c:rich>
                  <a:bodyPr/>
                  <a:lstStyle/>
                  <a:p>
                    <a:pPr>
                      <a:defRPr sz="1200" b="1"/>
                    </a:pPr>
                    <a:r>
                      <a:rPr lang="en-US" dirty="0"/>
                      <a:t>R² = </a:t>
                    </a:r>
                    <a:r>
                      <a:rPr lang="en-US" dirty="0" smtClean="0"/>
                      <a:t>0.67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errBars>
            <c:errDir val="y"/>
            <c:errBarType val="both"/>
            <c:errValType val="cust"/>
            <c:plus>
              <c:numRef>
                <c:f>Sheet1!$E$2:$E$9</c:f>
                <c:numCache>
                  <c:formatCode>General</c:formatCode>
                  <c:ptCount val="8"/>
                  <c:pt idx="0">
                    <c:v>8.5607588735450193</c:v>
                  </c:pt>
                  <c:pt idx="1">
                    <c:v>0.87921360790298597</c:v>
                  </c:pt>
                  <c:pt idx="2">
                    <c:v>2.3199018178457842</c:v>
                  </c:pt>
                  <c:pt idx="3">
                    <c:v>3.1362043951170744</c:v>
                  </c:pt>
                  <c:pt idx="4">
                    <c:v>3.0214116833495823</c:v>
                  </c:pt>
                  <c:pt idx="5">
                    <c:v>2.3304265176546157</c:v>
                  </c:pt>
                  <c:pt idx="6">
                    <c:v>2.3403274280252537</c:v>
                  </c:pt>
                  <c:pt idx="7">
                    <c:v>0.23629615382931476</c:v>
                  </c:pt>
                </c:numCache>
              </c:numRef>
            </c:plus>
            <c:minus>
              <c:numRef>
                <c:f>Sheet1!$E$2:$E$9</c:f>
                <c:numCache>
                  <c:formatCode>General</c:formatCode>
                  <c:ptCount val="8"/>
                  <c:pt idx="0">
                    <c:v>8.5607588735450193</c:v>
                  </c:pt>
                  <c:pt idx="1">
                    <c:v>0.87921360790298597</c:v>
                  </c:pt>
                  <c:pt idx="2">
                    <c:v>2.3199018178457842</c:v>
                  </c:pt>
                  <c:pt idx="3">
                    <c:v>3.1362043951170744</c:v>
                  </c:pt>
                  <c:pt idx="4">
                    <c:v>3.0214116833495823</c:v>
                  </c:pt>
                  <c:pt idx="5">
                    <c:v>2.3304265176546157</c:v>
                  </c:pt>
                  <c:pt idx="6">
                    <c:v>2.3403274280252537</c:v>
                  </c:pt>
                  <c:pt idx="7">
                    <c:v>0.23629615382931476</c:v>
                  </c:pt>
                </c:numCache>
              </c:numRef>
            </c:minus>
          </c:errBars>
          <c:xVal>
            <c:numRef>
              <c:f>Sheet1!$B$2:$B$9</c:f>
              <c:numCache>
                <c:formatCode>General</c:formatCode>
                <c:ptCount val="8"/>
                <c:pt idx="0">
                  <c:v>13.365753895886638</c:v>
                </c:pt>
                <c:pt idx="1">
                  <c:v>20.579525261377107</c:v>
                </c:pt>
                <c:pt idx="2">
                  <c:v>7.3280400062548843</c:v>
                </c:pt>
                <c:pt idx="3">
                  <c:v>4.7653900702636722</c:v>
                </c:pt>
                <c:pt idx="4">
                  <c:v>8.5056262674974779</c:v>
                </c:pt>
                <c:pt idx="5">
                  <c:v>3.1408483925437363</c:v>
                </c:pt>
                <c:pt idx="6">
                  <c:v>16.523975163963105</c:v>
                </c:pt>
                <c:pt idx="7">
                  <c:v>4.2641164189286158</c:v>
                </c:pt>
              </c:numCache>
            </c:numRef>
          </c:xVal>
          <c:yVal>
            <c:numRef>
              <c:f>Sheet1!$D$2:$D$9</c:f>
              <c:numCache>
                <c:formatCode>General</c:formatCode>
                <c:ptCount val="8"/>
                <c:pt idx="0">
                  <c:v>84.156378600823047</c:v>
                </c:pt>
                <c:pt idx="1">
                  <c:v>75.126903553299499</c:v>
                </c:pt>
                <c:pt idx="2">
                  <c:v>50.416666666666679</c:v>
                </c:pt>
                <c:pt idx="3">
                  <c:v>42.341040462427749</c:v>
                </c:pt>
                <c:pt idx="4">
                  <c:v>42.318435754189949</c:v>
                </c:pt>
                <c:pt idx="5">
                  <c:v>33.060109289617486</c:v>
                </c:pt>
                <c:pt idx="6">
                  <c:v>78.895184135977331</c:v>
                </c:pt>
                <c:pt idx="7">
                  <c:v>0.27285129604365621</c:v>
                </c:pt>
              </c:numCache>
            </c:numRef>
          </c:yVal>
        </c:ser>
        <c:axId val="50736512"/>
        <c:axId val="50746496"/>
      </c:scatterChart>
      <c:valAx>
        <c:axId val="50736512"/>
        <c:scaling>
          <c:orientation val="minMax"/>
        </c:scaling>
        <c:axPos val="b"/>
        <c:numFmt formatCode="General" sourceLinked="1"/>
        <c:tickLblPos val="nextTo"/>
        <c:crossAx val="50746496"/>
        <c:crosses val="autoZero"/>
        <c:crossBetween val="midCat"/>
      </c:valAx>
      <c:valAx>
        <c:axId val="50746496"/>
        <c:scaling>
          <c:orientation val="minMax"/>
        </c:scaling>
        <c:axPos val="l"/>
        <c:majorGridlines/>
        <c:numFmt formatCode="General" sourceLinked="1"/>
        <c:tickLblPos val="nextTo"/>
        <c:crossAx val="50736512"/>
        <c:crosses val="autoZero"/>
        <c:crossBetween val="midCat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AD7DD-B854-4B6D-876C-99032FFB05BB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04519-F5D0-446C-BA8E-B2FFE1E88C3D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899590" y="1314337"/>
            <a:ext cx="1872208" cy="1872208"/>
            <a:chOff x="4860032" y="703729"/>
            <a:chExt cx="2088231" cy="2160240"/>
          </a:xfrm>
        </p:grpSpPr>
        <p:graphicFrame>
          <p:nvGraphicFramePr>
            <p:cNvPr id="5" name="Chart 4"/>
            <p:cNvGraphicFramePr/>
            <p:nvPr/>
          </p:nvGraphicFramePr>
          <p:xfrm>
            <a:off x="4860032" y="703729"/>
            <a:ext cx="2088231" cy="19442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5436096" y="2586970"/>
              <a:ext cx="9417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Days in H2O</a:t>
              </a:r>
              <a:endParaRPr lang="en-GB" sz="1200" dirty="0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899592" y="3690602"/>
            <a:ext cx="1872208" cy="1898638"/>
            <a:chOff x="7308304" y="548680"/>
            <a:chExt cx="1944216" cy="2169145"/>
          </a:xfrm>
        </p:grpSpPr>
        <p:graphicFrame>
          <p:nvGraphicFramePr>
            <p:cNvPr id="8" name="Chart 7"/>
            <p:cNvGraphicFramePr/>
            <p:nvPr/>
          </p:nvGraphicFramePr>
          <p:xfrm>
            <a:off x="7308304" y="548680"/>
            <a:ext cx="1944216" cy="19511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7682192" y="2440826"/>
              <a:ext cx="15671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Days in spent medium</a:t>
              </a:r>
              <a:endParaRPr lang="en-GB" sz="1200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755575" y="95429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6a</a:t>
            </a:r>
            <a:endParaRPr lang="en-GB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55576" y="340257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6b</a:t>
            </a:r>
            <a:endParaRPr lang="en-GB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55576" y="404664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Supplementary Figure 6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218761" y="1851154"/>
            <a:ext cx="1206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Relative CFU (%)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195858" y="4322328"/>
            <a:ext cx="1252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lative CFU (%)</a:t>
            </a:r>
            <a:endParaRPr lang="en-GB" sz="1200" dirty="0"/>
          </a:p>
        </p:txBody>
      </p:sp>
      <p:graphicFrame>
        <p:nvGraphicFramePr>
          <p:cNvPr id="16" name="Chart 15"/>
          <p:cNvGraphicFramePr>
            <a:graphicFrameLocks noGrp="1"/>
          </p:cNvGraphicFramePr>
          <p:nvPr/>
        </p:nvGraphicFramePr>
        <p:xfrm>
          <a:off x="3707904" y="2420889"/>
          <a:ext cx="3744416" cy="15841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Chart 16"/>
          <p:cNvGraphicFramePr>
            <a:graphicFrameLocks noGrp="1"/>
          </p:cNvGraphicFramePr>
          <p:nvPr/>
        </p:nvGraphicFramePr>
        <p:xfrm>
          <a:off x="3707904" y="4365104"/>
          <a:ext cx="3744416" cy="1728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>
            <a:graphicFrameLocks noGrp="1"/>
          </p:cNvGraphicFramePr>
          <p:nvPr/>
        </p:nvGraphicFramePr>
        <p:xfrm>
          <a:off x="3707904" y="548681"/>
          <a:ext cx="3816424" cy="1512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Box 20"/>
          <p:cNvSpPr txBox="1"/>
          <p:nvPr/>
        </p:nvSpPr>
        <p:spPr>
          <a:xfrm rot="16200000">
            <a:off x="2658273" y="1166262"/>
            <a:ext cx="18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lative CFU at day </a:t>
            </a:r>
            <a:r>
              <a:rPr lang="en-GB" sz="1200" dirty="0" smtClean="0"/>
              <a:t>24 </a:t>
            </a:r>
            <a:r>
              <a:rPr lang="en-GB" sz="1200" dirty="0" smtClean="0"/>
              <a:t>(%)</a:t>
            </a:r>
            <a:endParaRPr lang="en-GB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4644008" y="1988840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Glycogen (</a:t>
            </a:r>
            <a:r>
              <a:rPr lang="en-GB" sz="1200" dirty="0" smtClean="0">
                <a:latin typeface="Calibri"/>
              </a:rPr>
              <a:t>µg glucose/mg cells)</a:t>
            </a:r>
            <a:endParaRPr lang="en-GB" sz="12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2658272" y="5054695"/>
            <a:ext cx="1800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lative CFU at day </a:t>
            </a:r>
            <a:r>
              <a:rPr lang="en-GB" sz="1200" dirty="0" smtClean="0"/>
              <a:t>24 </a:t>
            </a:r>
            <a:r>
              <a:rPr lang="en-GB" sz="1200" dirty="0" smtClean="0"/>
              <a:t>(%)</a:t>
            </a:r>
            <a:endParaRPr lang="en-GB" sz="12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2658272" y="3110479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lative CFU at day </a:t>
            </a:r>
            <a:r>
              <a:rPr lang="en-GB" sz="1200" dirty="0" smtClean="0"/>
              <a:t>24 </a:t>
            </a:r>
            <a:r>
              <a:rPr lang="en-GB" sz="1200" dirty="0" smtClean="0"/>
              <a:t>(%)</a:t>
            </a:r>
            <a:endParaRPr lang="en-GB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4644008" y="3933056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Trehalose</a:t>
            </a:r>
            <a:r>
              <a:rPr lang="en-GB" sz="1200" dirty="0" smtClean="0"/>
              <a:t> (</a:t>
            </a:r>
            <a:r>
              <a:rPr lang="en-GB" sz="1200" dirty="0" smtClean="0">
                <a:latin typeface="Calibri"/>
              </a:rPr>
              <a:t>µg </a:t>
            </a:r>
            <a:r>
              <a:rPr lang="en-GB" sz="1200" dirty="0" smtClean="0">
                <a:latin typeface="Calibri"/>
              </a:rPr>
              <a:t>glucose/mg cells)</a:t>
            </a:r>
            <a:endParaRPr lang="en-GB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4355976" y="6021288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Glycogen </a:t>
            </a:r>
            <a:r>
              <a:rPr lang="en-GB" sz="1200" dirty="0" smtClean="0"/>
              <a:t>+ </a:t>
            </a:r>
            <a:r>
              <a:rPr lang="en-GB" sz="1200" dirty="0" err="1" smtClean="0"/>
              <a:t>Trehalose</a:t>
            </a:r>
            <a:r>
              <a:rPr lang="en-GB" sz="1200" dirty="0" smtClean="0"/>
              <a:t> </a:t>
            </a:r>
            <a:r>
              <a:rPr lang="en-GB" sz="1200" dirty="0" smtClean="0"/>
              <a:t>(</a:t>
            </a:r>
            <a:r>
              <a:rPr lang="en-GB" sz="1200" dirty="0" smtClean="0">
                <a:latin typeface="Calibri"/>
              </a:rPr>
              <a:t>µg </a:t>
            </a:r>
            <a:r>
              <a:rPr lang="en-GB" sz="1200" dirty="0" smtClean="0">
                <a:latin typeface="Calibri"/>
              </a:rPr>
              <a:t>glucose/mg cells)</a:t>
            </a:r>
            <a:endParaRPr lang="en-GB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3131840" y="343689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6c</a:t>
            </a:r>
            <a:endParaRPr lang="en-GB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3131840" y="2215897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6d</a:t>
            </a:r>
            <a:endParaRPr lang="en-GB" sz="12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3131840" y="414908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6e</a:t>
            </a:r>
            <a:endParaRPr lang="en-GB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79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Cambridg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z228</dc:creator>
  <cp:lastModifiedBy>nz228</cp:lastModifiedBy>
  <cp:revision>13</cp:revision>
  <dcterms:created xsi:type="dcterms:W3CDTF">2016-05-13T12:39:19Z</dcterms:created>
  <dcterms:modified xsi:type="dcterms:W3CDTF">2016-09-23T21:38:00Z</dcterms:modified>
</cp:coreProperties>
</file>